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73" r:id="rId2"/>
  </p:sldMasterIdLst>
  <p:sldIdLst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4" d="100"/>
          <a:sy n="74" d="100"/>
        </p:scale>
        <p:origin x="732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1.xml"/><Relationship Id="rId7" Type="http://schemas.openxmlformats.org/officeDocument/2006/relationships/tableStyles" Target="tableStyle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23DD12-116E-441A-BD71-AB3E55CAE7B8}" type="datetimeFigureOut">
              <a:rPr lang="zh-CN" altLang="en-US" smtClean="0"/>
              <a:t>2017/9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9BF7B4-1050-4198-895B-285BFC0464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353242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23DD12-116E-441A-BD71-AB3E55CAE7B8}" type="datetimeFigureOut">
              <a:rPr lang="zh-CN" altLang="en-US" smtClean="0"/>
              <a:t>2017/9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9BF7B4-1050-4198-895B-285BFC0464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570889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23DD12-116E-441A-BD71-AB3E55CAE7B8}" type="datetimeFigureOut">
              <a:rPr lang="zh-CN" altLang="en-US" smtClean="0"/>
              <a:t>2017/9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9BF7B4-1050-4198-895B-285BFC0464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59103476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E0DB89-A573-4DE0-B1AE-18AA3520D3C9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12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5D111-37C2-4B4D-9D5A-AAD488D7AC88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20731606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E0DB89-A573-4DE0-B1AE-18AA3520D3C9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12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5D111-37C2-4B4D-9D5A-AAD488D7AC88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235246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E0DB89-A573-4DE0-B1AE-18AA3520D3C9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12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5D111-37C2-4B4D-9D5A-AAD488D7AC88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40872106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E0DB89-A573-4DE0-B1AE-18AA3520D3C9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12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5D111-37C2-4B4D-9D5A-AAD488D7AC88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22417637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E0DB89-A573-4DE0-B1AE-18AA3520D3C9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12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5D111-37C2-4B4D-9D5A-AAD488D7AC88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66945706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E0DB89-A573-4DE0-B1AE-18AA3520D3C9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12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5D111-37C2-4B4D-9D5A-AAD488D7AC88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3905761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E0DB89-A573-4DE0-B1AE-18AA3520D3C9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12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5D111-37C2-4B4D-9D5A-AAD488D7AC88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10102053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E0DB89-A573-4DE0-B1AE-18AA3520D3C9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12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5D111-37C2-4B4D-9D5A-AAD488D7AC88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200417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23DD12-116E-441A-BD71-AB3E55CAE7B8}" type="datetimeFigureOut">
              <a:rPr lang="zh-CN" altLang="en-US" smtClean="0"/>
              <a:t>2017/9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9BF7B4-1050-4198-895B-285BFC0464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42670839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E0DB89-A573-4DE0-B1AE-18AA3520D3C9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12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5D111-37C2-4B4D-9D5A-AAD488D7AC88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56852664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E0DB89-A573-4DE0-B1AE-18AA3520D3C9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12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5D111-37C2-4B4D-9D5A-AAD488D7AC88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41662057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E0DB89-A573-4DE0-B1AE-18AA3520D3C9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12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5D111-37C2-4B4D-9D5A-AAD488D7AC88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40746210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内容占位符 1"/>
          <p:cNvSpPr>
            <a:spLocks noGrp="1"/>
          </p:cNvSpPr>
          <p:nvPr>
            <p:ph/>
          </p:nvPr>
        </p:nvSpPr>
        <p:spPr>
          <a:xfrm>
            <a:off x="609600" y="274639"/>
            <a:ext cx="10972800" cy="5851525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B02B86-BCF5-4413-9803-488635CBE03C}" type="slidenum">
              <a:rPr lang="en-US" altLang="zh-CN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en-US" altLang="zh-CN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80919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23DD12-116E-441A-BD71-AB3E55CAE7B8}" type="datetimeFigureOut">
              <a:rPr lang="zh-CN" altLang="en-US" smtClean="0"/>
              <a:t>2017/9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9BF7B4-1050-4198-895B-285BFC0464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067605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23DD12-116E-441A-BD71-AB3E55CAE7B8}" type="datetimeFigureOut">
              <a:rPr lang="zh-CN" altLang="en-US" smtClean="0"/>
              <a:t>2017/9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9BF7B4-1050-4198-895B-285BFC0464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256428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23DD12-116E-441A-BD71-AB3E55CAE7B8}" type="datetimeFigureOut">
              <a:rPr lang="zh-CN" altLang="en-US" smtClean="0"/>
              <a:t>2017/9/1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9BF7B4-1050-4198-895B-285BFC0464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932872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23DD12-116E-441A-BD71-AB3E55CAE7B8}" type="datetimeFigureOut">
              <a:rPr lang="zh-CN" altLang="en-US" smtClean="0"/>
              <a:t>2017/9/1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9BF7B4-1050-4198-895B-285BFC0464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181422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23DD12-116E-441A-BD71-AB3E55CAE7B8}" type="datetimeFigureOut">
              <a:rPr lang="zh-CN" altLang="en-US" smtClean="0"/>
              <a:t>2017/9/1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9BF7B4-1050-4198-895B-285BFC0464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958390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23DD12-116E-441A-BD71-AB3E55CAE7B8}" type="datetimeFigureOut">
              <a:rPr lang="zh-CN" altLang="en-US" smtClean="0"/>
              <a:t>2017/9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9BF7B4-1050-4198-895B-285BFC0464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079072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23DD12-116E-441A-BD71-AB3E55CAE7B8}" type="datetimeFigureOut">
              <a:rPr lang="zh-CN" altLang="en-US" smtClean="0"/>
              <a:t>2017/9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9BF7B4-1050-4198-895B-285BFC0464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337608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13" Type="http://schemas.openxmlformats.org/officeDocument/2006/relationships/theme" Target="../theme/theme2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slideLayout" Target="../slideLayouts/slideLayout23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23DD12-116E-441A-BD71-AB3E55CAE7B8}" type="datetimeFigureOut">
              <a:rPr lang="zh-CN" altLang="en-US" smtClean="0"/>
              <a:t>2017/9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9BF7B4-1050-4198-895B-285BFC04645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943550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E0DB89-A573-4DE0-B1AE-18AA3520D3C9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7/9/12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85D111-37C2-4B4D-9D5A-AAD488D7AC88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248010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4" r:id="rId1"/>
    <p:sldLayoutId id="2147483675" r:id="rId2"/>
    <p:sldLayoutId id="2147483676" r:id="rId3"/>
    <p:sldLayoutId id="2147483677" r:id="rId4"/>
    <p:sldLayoutId id="2147483678" r:id="rId5"/>
    <p:sldLayoutId id="2147483679" r:id="rId6"/>
    <p:sldLayoutId id="2147483680" r:id="rId7"/>
    <p:sldLayoutId id="2147483681" r:id="rId8"/>
    <p:sldLayoutId id="2147483682" r:id="rId9"/>
    <p:sldLayoutId id="2147483683" r:id="rId10"/>
    <p:sldLayoutId id="2147483684" r:id="rId11"/>
    <p:sldLayoutId id="2147483685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04532" y="2807696"/>
            <a:ext cx="4037429" cy="441176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04531" y="3484591"/>
            <a:ext cx="4037430" cy="401999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  <p:sp>
        <p:nvSpPr>
          <p:cNvPr id="20" name="副标题 2"/>
          <p:cNvSpPr txBox="1">
            <a:spLocks/>
          </p:cNvSpPr>
          <p:nvPr/>
        </p:nvSpPr>
        <p:spPr>
          <a:xfrm>
            <a:off x="2993894" y="2838749"/>
            <a:ext cx="1335029" cy="379395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en-US" altLang="zh-CN" sz="20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PARα</a:t>
            </a:r>
            <a:endParaRPr lang="zh-CN" altLang="en-US" sz="20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副标题 2"/>
          <p:cNvSpPr txBox="1">
            <a:spLocks/>
          </p:cNvSpPr>
          <p:nvPr/>
        </p:nvSpPr>
        <p:spPr>
          <a:xfrm>
            <a:off x="2978904" y="3477221"/>
            <a:ext cx="1335029" cy="379395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en-US" altLang="zh-CN" sz="20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20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2" name="直接连接符 21"/>
          <p:cNvCxnSpPr/>
          <p:nvPr/>
        </p:nvCxnSpPr>
        <p:spPr>
          <a:xfrm flipV="1">
            <a:off x="4134511" y="2670536"/>
            <a:ext cx="1252025" cy="1"/>
          </a:xfrm>
          <a:prstGeom prst="line">
            <a:avLst/>
          </a:prstGeom>
          <a:ln w="349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接连接符 22"/>
          <p:cNvCxnSpPr/>
          <p:nvPr/>
        </p:nvCxnSpPr>
        <p:spPr>
          <a:xfrm flipV="1">
            <a:off x="5516105" y="2673036"/>
            <a:ext cx="1252025" cy="1"/>
          </a:xfrm>
          <a:prstGeom prst="line">
            <a:avLst/>
          </a:prstGeom>
          <a:ln w="349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接连接符 23"/>
          <p:cNvCxnSpPr/>
          <p:nvPr/>
        </p:nvCxnSpPr>
        <p:spPr>
          <a:xfrm flipV="1">
            <a:off x="6865215" y="2673036"/>
            <a:ext cx="1252025" cy="1"/>
          </a:xfrm>
          <a:prstGeom prst="line">
            <a:avLst/>
          </a:prstGeom>
          <a:ln w="349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副标题 2"/>
          <p:cNvSpPr txBox="1">
            <a:spLocks/>
          </p:cNvSpPr>
          <p:nvPr/>
        </p:nvSpPr>
        <p:spPr>
          <a:xfrm>
            <a:off x="4303168" y="2291545"/>
            <a:ext cx="914709" cy="295422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en-US" altLang="zh-CN" sz="20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 PF</a:t>
            </a:r>
            <a:endParaRPr lang="zh-CN" altLang="en-US" sz="20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副标题 2"/>
          <p:cNvSpPr txBox="1">
            <a:spLocks/>
          </p:cNvSpPr>
          <p:nvPr/>
        </p:nvSpPr>
        <p:spPr>
          <a:xfrm>
            <a:off x="5596201" y="2287358"/>
            <a:ext cx="1083368" cy="353129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en-US" altLang="zh-CN" sz="20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  AF</a:t>
            </a:r>
            <a:endParaRPr lang="zh-CN" altLang="en-US" sz="20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副标题 2"/>
          <p:cNvSpPr txBox="1">
            <a:spLocks/>
          </p:cNvSpPr>
          <p:nvPr/>
        </p:nvSpPr>
        <p:spPr>
          <a:xfrm>
            <a:off x="6911545" y="2248413"/>
            <a:ext cx="1118482" cy="441424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en-US" altLang="zh-CN" sz="24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 </a:t>
            </a:r>
            <a:r>
              <a:rPr lang="en-US" altLang="zh-CN" sz="20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FD</a:t>
            </a:r>
            <a:endParaRPr lang="zh-CN" altLang="en-US" sz="20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864818" y="5473521"/>
            <a:ext cx="87061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B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Use relevant software to scan the gray value of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3A 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o get the data 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矩形 6"/>
          <p:cNvSpPr/>
          <p:nvPr/>
        </p:nvSpPr>
        <p:spPr>
          <a:xfrm>
            <a:off x="864818" y="977652"/>
            <a:ext cx="112723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3A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6703930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2_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27</Words>
  <Application>Microsoft Office PowerPoint</Application>
  <PresentationFormat>宽屏</PresentationFormat>
  <Paragraphs>7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2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宋体</vt:lpstr>
      <vt:lpstr>Arial</vt:lpstr>
      <vt:lpstr>Calibri</vt:lpstr>
      <vt:lpstr>Calibri Light</vt:lpstr>
      <vt:lpstr>Times New Roman</vt:lpstr>
      <vt:lpstr>Office 主题</vt:lpstr>
      <vt:lpstr>2_Office 主题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bc</dc:creator>
  <cp:lastModifiedBy>abc</cp:lastModifiedBy>
  <cp:revision>1</cp:revision>
  <dcterms:created xsi:type="dcterms:W3CDTF">2017-09-12T12:22:41Z</dcterms:created>
  <dcterms:modified xsi:type="dcterms:W3CDTF">2017-09-12T12:26:01Z</dcterms:modified>
</cp:coreProperties>
</file>